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19" autoAdjust="0"/>
    <p:restoredTop sz="94660"/>
  </p:normalViewPr>
  <p:slideViewPr>
    <p:cSldViewPr snapToGrid="0">
      <p:cViewPr varScale="1">
        <p:scale>
          <a:sx n="66" d="100"/>
          <a:sy n="66" d="100"/>
        </p:scale>
        <p:origin x="3006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D972D-0447-46D6-99B4-1A9A38431296}" type="datetimeFigureOut">
              <a:rPr lang="en-CA" smtClean="0"/>
              <a:t>2018-01-1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7490E-A92D-4B83-BF57-C87D2677E73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401557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D972D-0447-46D6-99B4-1A9A38431296}" type="datetimeFigureOut">
              <a:rPr lang="en-CA" smtClean="0"/>
              <a:t>2018-01-1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7490E-A92D-4B83-BF57-C87D2677E73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415668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D972D-0447-46D6-99B4-1A9A38431296}" type="datetimeFigureOut">
              <a:rPr lang="en-CA" smtClean="0"/>
              <a:t>2018-01-1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7490E-A92D-4B83-BF57-C87D2677E73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15372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D972D-0447-46D6-99B4-1A9A38431296}" type="datetimeFigureOut">
              <a:rPr lang="en-CA" smtClean="0"/>
              <a:t>2018-01-1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7490E-A92D-4B83-BF57-C87D2677E73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934033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D972D-0447-46D6-99B4-1A9A38431296}" type="datetimeFigureOut">
              <a:rPr lang="en-CA" smtClean="0"/>
              <a:t>2018-01-1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7490E-A92D-4B83-BF57-C87D2677E73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308456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D972D-0447-46D6-99B4-1A9A38431296}" type="datetimeFigureOut">
              <a:rPr lang="en-CA" smtClean="0"/>
              <a:t>2018-01-19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7490E-A92D-4B83-BF57-C87D2677E73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247026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D972D-0447-46D6-99B4-1A9A38431296}" type="datetimeFigureOut">
              <a:rPr lang="en-CA" smtClean="0"/>
              <a:t>2018-01-19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7490E-A92D-4B83-BF57-C87D2677E73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61343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D972D-0447-46D6-99B4-1A9A38431296}" type="datetimeFigureOut">
              <a:rPr lang="en-CA" smtClean="0"/>
              <a:t>2018-01-19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7490E-A92D-4B83-BF57-C87D2677E73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73176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D972D-0447-46D6-99B4-1A9A38431296}" type="datetimeFigureOut">
              <a:rPr lang="en-CA" smtClean="0"/>
              <a:t>2018-01-19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7490E-A92D-4B83-BF57-C87D2677E73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582541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D972D-0447-46D6-99B4-1A9A38431296}" type="datetimeFigureOut">
              <a:rPr lang="en-CA" smtClean="0"/>
              <a:t>2018-01-19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7490E-A92D-4B83-BF57-C87D2677E73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231040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D972D-0447-46D6-99B4-1A9A38431296}" type="datetimeFigureOut">
              <a:rPr lang="en-CA" smtClean="0"/>
              <a:t>2018-01-19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7490E-A92D-4B83-BF57-C87D2677E73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480310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FD972D-0447-46D6-99B4-1A9A38431296}" type="datetimeFigureOut">
              <a:rPr lang="en-CA" smtClean="0"/>
              <a:t>2018-01-1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F7490E-A92D-4B83-BF57-C87D2677E73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915448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/>
          <a:srcRect t="13614" b="25002"/>
          <a:stretch/>
        </p:blipFill>
        <p:spPr>
          <a:xfrm>
            <a:off x="2082312" y="4622800"/>
            <a:ext cx="4077188" cy="1502966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3"/>
          <a:srcRect t="15245" b="25135"/>
          <a:stretch/>
        </p:blipFill>
        <p:spPr>
          <a:xfrm>
            <a:off x="2082312" y="609599"/>
            <a:ext cx="4077188" cy="1459777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4"/>
          <a:srcRect t="17032" b="25465"/>
          <a:stretch/>
        </p:blipFill>
        <p:spPr>
          <a:xfrm>
            <a:off x="2082312" y="6705599"/>
            <a:ext cx="4077188" cy="1407951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5"/>
          <a:srcRect t="16193" b="27009"/>
          <a:stretch/>
        </p:blipFill>
        <p:spPr>
          <a:xfrm>
            <a:off x="2082312" y="2647949"/>
            <a:ext cx="4077188" cy="1390675"/>
          </a:xfrm>
          <a:prstGeom prst="rect">
            <a:avLst/>
          </a:prstGeom>
        </p:spPr>
      </p:pic>
      <p:sp>
        <p:nvSpPr>
          <p:cNvPr id="10" name="ZoneTexte 9"/>
          <p:cNvSpPr txBox="1"/>
          <p:nvPr/>
        </p:nvSpPr>
        <p:spPr>
          <a:xfrm>
            <a:off x="3913231" y="216894"/>
            <a:ext cx="8367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A" sz="1400" b="1" dirty="0" smtClean="0"/>
              <a:t>DTM</a:t>
            </a:r>
            <a:endParaRPr lang="en-CA" sz="1400" b="1" dirty="0"/>
          </a:p>
        </p:txBody>
      </p:sp>
      <p:sp>
        <p:nvSpPr>
          <p:cNvPr id="11" name="ZoneTexte 9"/>
          <p:cNvSpPr txBox="1"/>
          <p:nvPr/>
        </p:nvSpPr>
        <p:spPr>
          <a:xfrm>
            <a:off x="3913231" y="2251272"/>
            <a:ext cx="8367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A" sz="1400" b="1" dirty="0" smtClean="0"/>
              <a:t>DTF</a:t>
            </a:r>
            <a:endParaRPr lang="en-CA" sz="1400" b="1" dirty="0"/>
          </a:p>
        </p:txBody>
      </p:sp>
      <p:sp>
        <p:nvSpPr>
          <p:cNvPr id="12" name="ZoneTexte 9"/>
          <p:cNvSpPr txBox="1"/>
          <p:nvPr/>
        </p:nvSpPr>
        <p:spPr>
          <a:xfrm>
            <a:off x="3913231" y="4325261"/>
            <a:ext cx="8367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A" sz="1400" b="1" dirty="0" smtClean="0"/>
              <a:t>DTPF</a:t>
            </a:r>
            <a:endParaRPr lang="en-CA" sz="1400" b="1" dirty="0"/>
          </a:p>
        </p:txBody>
      </p:sp>
      <p:sp>
        <p:nvSpPr>
          <p:cNvPr id="13" name="ZoneTexte 9"/>
          <p:cNvSpPr txBox="1"/>
          <p:nvPr/>
        </p:nvSpPr>
        <p:spPr>
          <a:xfrm>
            <a:off x="3913230" y="6321622"/>
            <a:ext cx="8367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A" sz="1400" b="1" dirty="0" smtClean="0"/>
              <a:t>SW</a:t>
            </a:r>
            <a:endParaRPr lang="en-CA" sz="1400" b="1" dirty="0"/>
          </a:p>
        </p:txBody>
      </p:sp>
      <p:sp>
        <p:nvSpPr>
          <p:cNvPr id="14" name="ZoneTexte 9"/>
          <p:cNvSpPr txBox="1"/>
          <p:nvPr/>
        </p:nvSpPr>
        <p:spPr>
          <a:xfrm>
            <a:off x="3913230" y="8359972"/>
            <a:ext cx="8367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A" sz="1400" b="1" dirty="0" err="1" smtClean="0"/>
              <a:t>Yield</a:t>
            </a:r>
            <a:endParaRPr lang="en-CA" sz="1400" b="1" dirty="0"/>
          </a:p>
        </p:txBody>
      </p:sp>
      <p:pic>
        <p:nvPicPr>
          <p:cNvPr id="16" name="Picture 15"/>
          <p:cNvPicPr>
            <a:picLocks noChangeAspect="1"/>
          </p:cNvPicPr>
          <p:nvPr/>
        </p:nvPicPr>
        <p:blipFill rotWithShape="1">
          <a:blip r:embed="rId6"/>
          <a:srcRect t="15356"/>
          <a:stretch/>
        </p:blipFill>
        <p:spPr>
          <a:xfrm>
            <a:off x="2080700" y="8693383"/>
            <a:ext cx="4078800" cy="2073316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3899055" y="9183056"/>
            <a:ext cx="863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A" sz="1400" b="1" dirty="0" smtClean="0"/>
              <a:t>***</a:t>
            </a:r>
            <a:endParaRPr lang="en-CA" sz="14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3810155" y="6726579"/>
            <a:ext cx="863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A" sz="1400" b="1" dirty="0" smtClean="0"/>
              <a:t>***</a:t>
            </a:r>
            <a:endParaRPr lang="en-CA" sz="14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4997682" y="6895611"/>
            <a:ext cx="863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A" sz="1400" b="1" dirty="0" smtClean="0"/>
              <a:t>***</a:t>
            </a:r>
            <a:endParaRPr lang="en-CA" sz="140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3857664" y="1156220"/>
            <a:ext cx="863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A" sz="1400" b="1" dirty="0" smtClean="0"/>
              <a:t>***</a:t>
            </a:r>
            <a:endParaRPr lang="en-CA" sz="1400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5007091" y="753752"/>
            <a:ext cx="863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A" sz="1400" b="1" dirty="0" smtClean="0"/>
              <a:t>***</a:t>
            </a:r>
            <a:endParaRPr lang="en-CA" sz="1400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5007091" y="2647949"/>
            <a:ext cx="863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A" sz="1400" b="1" dirty="0" smtClean="0"/>
              <a:t>***</a:t>
            </a:r>
            <a:endParaRPr lang="en-CA" sz="14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3822855" y="4784210"/>
            <a:ext cx="863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A" sz="1400" b="1" dirty="0" smtClean="0"/>
              <a:t>***</a:t>
            </a:r>
            <a:endParaRPr lang="en-CA" sz="1400" b="1" dirty="0"/>
          </a:p>
        </p:txBody>
      </p:sp>
      <p:sp>
        <p:nvSpPr>
          <p:cNvPr id="24" name="TextBox 23"/>
          <p:cNvSpPr txBox="1"/>
          <p:nvPr/>
        </p:nvSpPr>
        <p:spPr>
          <a:xfrm>
            <a:off x="5007246" y="4788985"/>
            <a:ext cx="863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A" sz="1400" b="1" dirty="0" smtClean="0"/>
              <a:t>*</a:t>
            </a:r>
            <a:endParaRPr lang="en-CA" sz="1400" b="1" dirty="0"/>
          </a:p>
        </p:txBody>
      </p:sp>
      <p:sp>
        <p:nvSpPr>
          <p:cNvPr id="25" name="TextBox 24"/>
          <p:cNvSpPr txBox="1"/>
          <p:nvPr/>
        </p:nvSpPr>
        <p:spPr>
          <a:xfrm>
            <a:off x="469900" y="11235366"/>
            <a:ext cx="62230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</a:t>
            </a:r>
            <a:r>
              <a:rPr lang="fr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le 2.  </a:t>
            </a:r>
            <a:r>
              <a:rPr lang="fr-CA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verage</a:t>
            </a:r>
            <a:r>
              <a:rPr lang="fr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rait values </a:t>
            </a:r>
            <a:r>
              <a:rPr lang="fr-CA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ross</a:t>
            </a:r>
            <a:r>
              <a:rPr lang="fr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he 5 site-</a:t>
            </a:r>
            <a:r>
              <a:rPr lang="fr-CA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ears</a:t>
            </a:r>
            <a:r>
              <a:rPr lang="fr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 Bars </a:t>
            </a:r>
            <a:r>
              <a:rPr lang="fr-CA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</a:t>
            </a:r>
            <a:r>
              <a:rPr lang="fr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tandard </a:t>
            </a:r>
            <a:r>
              <a:rPr lang="fr-CA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viations</a:t>
            </a:r>
            <a:r>
              <a:rPr lang="fr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or </a:t>
            </a:r>
            <a:r>
              <a:rPr lang="fr-CA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ach</a:t>
            </a:r>
            <a:r>
              <a:rPr lang="fr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ite-</a:t>
            </a:r>
            <a:r>
              <a:rPr lang="fr-CA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ear</a:t>
            </a:r>
            <a:r>
              <a:rPr lang="fr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 Stars </a:t>
            </a:r>
            <a:r>
              <a:rPr lang="fr-CA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</a:t>
            </a:r>
            <a:r>
              <a:rPr lang="fr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CA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gnificant</a:t>
            </a:r>
            <a:r>
              <a:rPr lang="fr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CA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fferences</a:t>
            </a:r>
            <a:r>
              <a:rPr lang="fr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CA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etween</a:t>
            </a:r>
            <a:r>
              <a:rPr lang="fr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ites for a </a:t>
            </a:r>
            <a:r>
              <a:rPr lang="fr-CA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iven</a:t>
            </a:r>
            <a:r>
              <a:rPr lang="fr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CA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ear</a:t>
            </a:r>
            <a:r>
              <a:rPr lang="fr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fr-CA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here</a:t>
            </a:r>
            <a:r>
              <a:rPr lang="fr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*</a:t>
            </a:r>
            <a:r>
              <a:rPr lang="fr-CA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fr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&lt;0.05, **</a:t>
            </a:r>
            <a:r>
              <a:rPr lang="fr-CA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fr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&lt;0.01 and ***</a:t>
            </a:r>
            <a:r>
              <a:rPr lang="fr-CA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fr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&lt;0.001using </a:t>
            </a:r>
            <a:r>
              <a:rPr lang="fr-CA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ukey’s</a:t>
            </a:r>
            <a:r>
              <a:rPr lang="fr-CA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HSD tests. 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TM, days to maturity; DTF, days to flowering; DTPF, days to pod filling; SW, 100 seed weight; Yield (kg ha</a:t>
            </a:r>
            <a:r>
              <a:rPr lang="en-CA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; Bel, Saint-Mathieu-de-Beloeil site; QC, Québec City site.</a:t>
            </a:r>
          </a:p>
          <a:p>
            <a:endParaRPr lang="en-C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 rot="16200000">
            <a:off x="1140503" y="1185598"/>
            <a:ext cx="1306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A" sz="1400" b="1" dirty="0" err="1" smtClean="0"/>
              <a:t>Days</a:t>
            </a:r>
            <a:endParaRPr lang="en-CA" sz="1400" b="1" dirty="0"/>
          </a:p>
        </p:txBody>
      </p:sp>
      <p:sp>
        <p:nvSpPr>
          <p:cNvPr id="27" name="TextBox 26"/>
          <p:cNvSpPr txBox="1"/>
          <p:nvPr/>
        </p:nvSpPr>
        <p:spPr>
          <a:xfrm rot="16200000">
            <a:off x="1243034" y="3189397"/>
            <a:ext cx="1306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A" sz="1400" b="1" dirty="0" err="1" smtClean="0"/>
              <a:t>Days</a:t>
            </a:r>
            <a:endParaRPr lang="en-CA" sz="1400" b="1" dirty="0"/>
          </a:p>
        </p:txBody>
      </p:sp>
      <p:sp>
        <p:nvSpPr>
          <p:cNvPr id="28" name="TextBox 27"/>
          <p:cNvSpPr txBox="1"/>
          <p:nvPr/>
        </p:nvSpPr>
        <p:spPr>
          <a:xfrm rot="16200000">
            <a:off x="1243034" y="5223512"/>
            <a:ext cx="1306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A" sz="1400" b="1" dirty="0" err="1" smtClean="0"/>
              <a:t>Days</a:t>
            </a:r>
            <a:endParaRPr lang="en-CA" sz="1400" b="1" dirty="0"/>
          </a:p>
        </p:txBody>
      </p:sp>
      <p:sp>
        <p:nvSpPr>
          <p:cNvPr id="29" name="TextBox 28"/>
          <p:cNvSpPr txBox="1"/>
          <p:nvPr/>
        </p:nvSpPr>
        <p:spPr>
          <a:xfrm rot="16200000">
            <a:off x="1243033" y="7251001"/>
            <a:ext cx="1306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A" sz="1400" b="1" dirty="0" smtClean="0"/>
              <a:t>Grams</a:t>
            </a:r>
            <a:endParaRPr lang="en-CA" sz="1400" b="1" dirty="0"/>
          </a:p>
        </p:txBody>
      </p:sp>
      <p:sp>
        <p:nvSpPr>
          <p:cNvPr id="30" name="TextBox 29"/>
          <p:cNvSpPr txBox="1"/>
          <p:nvPr/>
        </p:nvSpPr>
        <p:spPr>
          <a:xfrm rot="16200000">
            <a:off x="1243033" y="9165980"/>
            <a:ext cx="1306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A" sz="1400" b="1" dirty="0"/>
              <a:t>k</a:t>
            </a:r>
            <a:r>
              <a:rPr lang="fr-CA" sz="1400" b="1" dirty="0" smtClean="0"/>
              <a:t>g ha</a:t>
            </a:r>
            <a:r>
              <a:rPr lang="fr-CA" sz="1400" b="1" baseline="30000" dirty="0" smtClean="0"/>
              <a:t>-1</a:t>
            </a:r>
            <a:endParaRPr lang="en-CA" sz="1400" b="1" baseline="30000" dirty="0"/>
          </a:p>
        </p:txBody>
      </p:sp>
    </p:spTree>
    <p:extLst>
      <p:ext uri="{BB962C8B-B14F-4D97-AF65-F5344CB8AC3E}">
        <p14:creationId xmlns:p14="http://schemas.microsoft.com/office/powerpoint/2010/main" val="32447108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6</TotalTime>
  <Words>104</Words>
  <Application>Microsoft Office PowerPoint</Application>
  <PresentationFormat>Widescreen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rtographie Moleculaire</dc:creator>
  <cp:lastModifiedBy>Cartographie Moleculaire</cp:lastModifiedBy>
  <cp:revision>10</cp:revision>
  <dcterms:created xsi:type="dcterms:W3CDTF">2018-01-19T16:34:32Z</dcterms:created>
  <dcterms:modified xsi:type="dcterms:W3CDTF">2018-01-19T20:25:04Z</dcterms:modified>
</cp:coreProperties>
</file>